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19" autoAdjust="0"/>
  </p:normalViewPr>
  <p:slideViewPr>
    <p:cSldViewPr>
      <p:cViewPr>
        <p:scale>
          <a:sx n="70" d="100"/>
          <a:sy n="70" d="100"/>
        </p:scale>
        <p:origin x="-1716" y="-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C127A-65D9-4257-AB54-BFF2575DCB07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D48EF-94A9-49AB-8904-D956D12BAD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989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CA2C36-B6DE-4864-9339-FADEE753FB8F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B7C45-EAAB-475C-BF0F-6EA14F973924}" type="datetimeFigureOut">
              <a:rPr lang="en-GB" smtClean="0"/>
              <a:pPr/>
              <a:t>05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32656" y="853012"/>
            <a:ext cx="6264696" cy="7319388"/>
            <a:chOff x="332656" y="179512"/>
            <a:chExt cx="6264696" cy="8237010"/>
          </a:xfrm>
        </p:grpSpPr>
        <p:sp>
          <p:nvSpPr>
            <p:cNvPr id="11" name="Rectangle 6"/>
            <p:cNvSpPr>
              <a:spLocks noChangeAspect="1" noChangeArrowheads="1"/>
            </p:cNvSpPr>
            <p:nvPr/>
          </p:nvSpPr>
          <p:spPr bwMode="auto">
            <a:xfrm>
              <a:off x="333352" y="8104796"/>
              <a:ext cx="6264000" cy="3117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algn="just" fontAlgn="base">
                <a:spcBef>
                  <a:spcPct val="0"/>
                </a:spcBef>
                <a:spcAft>
                  <a:spcPct val="0"/>
                </a:spcAft>
              </a:pPr>
              <a:endPara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32656" y="179512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A)</a:t>
              </a:r>
              <a:endParaRPr lang="en-GB" sz="1000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489302" y="179512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B)</a:t>
              </a:r>
              <a:endParaRPr lang="en-GB" sz="10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76119" y="2028541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C)</a:t>
              </a:r>
              <a:endParaRPr lang="en-GB" sz="10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489302" y="2028541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D)</a:t>
              </a:r>
              <a:endParaRPr lang="en-GB" sz="10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01415" y="3874309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E)</a:t>
              </a:r>
              <a:endParaRPr lang="en-GB" sz="10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489302" y="3874309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F)</a:t>
              </a:r>
              <a:endParaRPr lang="en-GB" sz="10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01415" y="5674509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G)</a:t>
              </a:r>
              <a:endParaRPr lang="en-GB" sz="10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489302" y="5674509"/>
              <a:ext cx="460593" cy="193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H)</a:t>
              </a:r>
              <a:endParaRPr lang="en-GB" sz="1000" b="1" dirty="0"/>
            </a:p>
          </p:txBody>
        </p:sp>
        <p:graphicFrame>
          <p:nvGraphicFramePr>
            <p:cNvPr id="5123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82848031"/>
                </p:ext>
              </p:extLst>
            </p:nvPr>
          </p:nvGraphicFramePr>
          <p:xfrm>
            <a:off x="685559" y="179512"/>
            <a:ext cx="5911097" cy="74104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34" name="Prism 5" r:id="rId4" imgW="6320160" imgH="9706320" progId="Prism5.Document">
                    <p:embed/>
                  </p:oleObj>
                </mc:Choice>
                <mc:Fallback>
                  <p:oleObj name="Prism 5" r:id="rId4" imgW="6320160" imgH="9706320" progId="Prism5.Document">
                    <p:embed/>
                    <p:pic>
                      <p:nvPicPr>
                        <p:cNvPr id="0" name="Picture 10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85559" y="179512"/>
                          <a:ext cx="5911097" cy="741048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4" name="Rectangle 3"/>
          <p:cNvSpPr>
            <a:spLocks noChangeAspect="1" noChangeArrowheads="1"/>
          </p:cNvSpPr>
          <p:nvPr/>
        </p:nvSpPr>
        <p:spPr bwMode="auto">
          <a:xfrm>
            <a:off x="0" y="386244"/>
            <a:ext cx="6228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GB" b="1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Additional File 8</a:t>
            </a:r>
            <a:endParaRPr kumimoji="0" lang="en-GB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131" name="Rectangle 11"/>
          <p:cNvSpPr>
            <a:spLocks noChangeArrowheads="1"/>
          </p:cNvSpPr>
          <p:nvPr/>
        </p:nvSpPr>
        <p:spPr bwMode="auto">
          <a:xfrm>
            <a:off x="0" y="7736576"/>
            <a:ext cx="685800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The effect of LXR activation on macrophage polarisation. 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lveolar macrophages from smoking controls (A, C, E, and G) (n=8 apart from at 10 µM n=5) and COPD patients (B, D, F, and H) (n=9 apart from at 10 µM n=3) were treated with or without GW3965 (1 µM and 10 µM) for 4, 24 and 48 h.  RNA was extracted for PCR analysis of HO-1 (A and B), CD36 (C and D), MR (E and F) and TLR4 (G and H) mRNA expression.  Data shown are mean ± SEM of fold increase of mRNA expression above time matched controls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156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GraphPad Prism 5 Projec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imon Lea</dc:creator>
  <cp:lastModifiedBy>Andrew Higham</cp:lastModifiedBy>
  <cp:revision>46</cp:revision>
  <dcterms:created xsi:type="dcterms:W3CDTF">2012-05-28T12:09:01Z</dcterms:created>
  <dcterms:modified xsi:type="dcterms:W3CDTF">2013-09-05T09:16:25Z</dcterms:modified>
</cp:coreProperties>
</file>